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0" r:id="rId3"/>
    <p:sldId id="275" r:id="rId4"/>
    <p:sldId id="281" r:id="rId5"/>
    <p:sldId id="27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76565-75EB-9A95-61A0-CD7BB7B0BE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ACD745-064D-83AE-4AAD-55D02194EB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05B778-F521-1947-26D4-9C70C954E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00DAB3-D982-479A-2904-1E3AED56C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342AE-93F3-B01C-052D-8B8FA6143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429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0A6EE-D880-F939-985F-3218939217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32E4A1-45CA-CBD8-25C3-171C7EDA9A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1F3C25-E41A-DAEF-7EAF-ED56E1F3B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BE1C02-6428-1DB3-8B02-3048BF6F0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32642C-C1ED-31A0-67B9-8B098B9C2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751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5937BE-4A8A-FE6B-9072-D32B26CD22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EDAC8B-1BB7-2714-FB9C-88EF36433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74736B-7512-C1A6-DB99-9BF4C0191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3CCCE-9BFF-9DEA-5A12-4D8E535F0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63D9B-FCCE-2A31-FBE2-7EACE2C48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29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F1006-C198-EE96-CB70-6ADB2A35A0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65B31E-FD44-AAAD-EA71-B867332DDC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39DEF2-E91B-D50E-A4B5-C07FD3523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A97F2-7503-595F-79D8-ED133050B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8BA92-6C63-268C-03E8-9447CFCF4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251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54066-AA81-AC8C-1B4D-B6C72EF61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577C68-7549-A39A-851D-4090E0920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017DB-C53A-19E4-239A-BD44A162D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CBCA0-BEC6-3CC3-3852-1BD236312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DACEE-C4B2-F71E-C1E7-E737C222B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97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173A8-C4E3-7853-C947-1E6EBE019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02A48D-72F6-87F9-30FE-8F46A32EB6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4C063F-2FC7-F3AA-3784-AD2F8AB134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E468A7-C93A-D6D1-9EF9-A3292BBD3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0D21D1-D13D-4258-8D3B-EFD5A3043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F8DADC-B9A0-392C-28AC-319E8D22F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67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8CB86-D2D9-AAF8-EE15-18C9DA14E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A5F35A-901D-8358-E79D-8A280C8E93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C47D68-9326-6F9C-A628-D78633BA0B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88B260-3492-B003-977D-427A129973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521B44-4453-7384-6F3C-F1F4A79119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32DE4D-EF42-4521-C679-667F4E91C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314F9C-9273-0A57-E1DE-A131ABFF9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4CBB054-0D0E-F7E7-1300-85E8A6792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203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6C588-2718-630B-7329-630C2DC4F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794094-7C0C-6935-77BF-3BD34C75A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816D18-1458-26BD-C46E-0176971BA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7E8A16-16EB-EDA7-ECED-97F880FAB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384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D9CACE-BF82-F457-5035-E87465F14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013C52-8281-7717-11BA-E0485DDAD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9004DE-DB68-1207-F9BC-6B77C1A20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093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194636-5F24-05D2-2DBA-DC636AB07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8C3AAE-2D98-79F0-EA7E-8658E860DA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360A2C-F8A5-37F5-6A8C-A4850AE25F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C0D1F0-4503-3C45-9923-C96B2C574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1899E7-9ECF-9095-1F03-CB9EFACDE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1A1717-0CA4-2E6E-4B4C-B3860E471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789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578928-6DDC-1BA7-AECA-0F932FEB1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7DA91F-CA44-71B4-1E03-B4A81F3493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10E4EF-E58D-0C89-9621-5BAA7696A7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E55002-118D-E16F-0F7D-5B780217C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31CE6C-C5DB-C7CA-5148-4B098C072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240A85-F4BA-321B-372A-3F01A7D40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25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ED9EAB-F481-9674-F660-FA7A76A37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44AE55-C132-E37A-B4C3-34FC689361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146137-7EC9-3A4C-FBED-8C053B43B8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EBE56-46F2-48CE-82EE-E35807A62F0D}" type="datetimeFigureOut">
              <a:rPr lang="en-US" smtClean="0"/>
              <a:t>5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D73B72-E7D7-DD66-469B-50B429BC15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58BFA-B1C2-E7EE-8D7A-29B5C8EE48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05AFD-FE1F-419E-94B6-3A958FDB5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33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660E73-663A-7926-D983-62EDE6D6F03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263FAB4-4C71-3C97-AAF7-59F184830B1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3800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9" descr="A picture containing map, snow&#10;&#10;Description automatically generated">
            <a:extLst>
              <a:ext uri="{FF2B5EF4-FFF2-40B4-BE49-F238E27FC236}">
                <a16:creationId xmlns:a16="http://schemas.microsoft.com/office/drawing/2014/main" id="{6742738F-8989-62A2-9C30-1E522A4B87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552" y="643466"/>
            <a:ext cx="9132896" cy="55710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37858E-B67C-A44C-9453-08B4C898B033}"/>
              </a:ext>
            </a:extLst>
          </p:cNvPr>
          <p:cNvSpPr txBox="1"/>
          <p:nvPr/>
        </p:nvSpPr>
        <p:spPr>
          <a:xfrm>
            <a:off x="1567775" y="6258811"/>
            <a:ext cx="5657318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86968">
              <a:spcAft>
                <a:spcPts val="600"/>
              </a:spcAft>
            </a:pP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Figure </a:t>
            </a:r>
            <a:r>
              <a:rPr lang="en-US" sz="1164" dirty="0"/>
              <a:t>S1</a:t>
            </a: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Representative picture of ROR1 IHC expression in Mesotheliom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89574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D586DB93-2B85-43B7-B48F-EF98C18541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7775" y="669966"/>
            <a:ext cx="9056450" cy="55180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039EA8E-069D-423B-91D0-3E88548A2E88}"/>
              </a:ext>
            </a:extLst>
          </p:cNvPr>
          <p:cNvSpPr txBox="1"/>
          <p:nvPr/>
        </p:nvSpPr>
        <p:spPr>
          <a:xfrm>
            <a:off x="1567775" y="6258811"/>
            <a:ext cx="5618846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86968">
              <a:spcAft>
                <a:spcPts val="600"/>
              </a:spcAft>
            </a:pP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Figure </a:t>
            </a:r>
            <a:r>
              <a:rPr lang="en-US" sz="1164" dirty="0"/>
              <a:t>S</a:t>
            </a: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2: Representative picture of ROR1 IHC expression in Liposarcoma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34011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5861124-AA5E-C494-9CF9-4D7ECE5A51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552" y="643466"/>
            <a:ext cx="9132896" cy="557106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410EC0-3E6F-706D-38CC-FD6367033973}"/>
              </a:ext>
            </a:extLst>
          </p:cNvPr>
          <p:cNvSpPr txBox="1"/>
          <p:nvPr/>
        </p:nvSpPr>
        <p:spPr>
          <a:xfrm>
            <a:off x="1567775" y="6258811"/>
            <a:ext cx="5091458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86968">
              <a:spcAft>
                <a:spcPts val="600"/>
              </a:spcAft>
            </a:pP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Figure </a:t>
            </a:r>
            <a:r>
              <a:rPr lang="en-US" sz="1164" dirty="0"/>
              <a:t>S3</a:t>
            </a: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Representative picture of ROR1 IHC expression in GIS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635168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0E03395-6D73-72A9-CB97-B64C8615DE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552" y="643466"/>
            <a:ext cx="9132896" cy="557106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F2D2A80-D34C-34FB-692F-9F177587A2CE}"/>
              </a:ext>
            </a:extLst>
          </p:cNvPr>
          <p:cNvSpPr txBox="1"/>
          <p:nvPr/>
        </p:nvSpPr>
        <p:spPr>
          <a:xfrm>
            <a:off x="1567775" y="6258811"/>
            <a:ext cx="6631944" cy="271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86968">
              <a:spcAft>
                <a:spcPts val="600"/>
              </a:spcAft>
            </a:pPr>
            <a:r>
              <a:rPr lang="en-US" sz="1164" kern="120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Figure </a:t>
            </a:r>
            <a:r>
              <a:rPr lang="en-US" sz="1164"/>
              <a:t>S4</a:t>
            </a:r>
            <a:r>
              <a:rPr lang="en-US" sz="1164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Representative picture of ROR1 IHC expression in Endometroid Adenocarcinom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37944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3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</vt:vector>
  </TitlesOfParts>
  <Company>M.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Raso,Gabriela</dc:creator>
  <cp:lastModifiedBy>MDPI</cp:lastModifiedBy>
  <cp:revision>2</cp:revision>
  <dcterms:created xsi:type="dcterms:W3CDTF">2024-05-03T22:38:45Z</dcterms:created>
  <dcterms:modified xsi:type="dcterms:W3CDTF">2024-05-15T03:51:03Z</dcterms:modified>
</cp:coreProperties>
</file>